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10" d="100"/>
          <a:sy n="110" d="100"/>
        </p:scale>
        <p:origin x="678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1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2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3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4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____5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LP</a:t>
            </a:r>
          </a:p>
        </c:rich>
      </c:tx>
      <c:layout>
        <c:manualLayout>
          <c:xMode val="edge"/>
          <c:yMode val="edge"/>
          <c:x val="0.51870822397200345"/>
          <c:y val="4.6296296296296294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PN &amp; DP0.1G.....1 '!$L$178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77:$O$177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78:$O$178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DPN &amp; DP0.1G.....1 '!$L$179</c:f>
              <c:strCache>
                <c:ptCount val="1"/>
                <c:pt idx="0">
                  <c:v>Gel-c U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77:$O$177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79:$O$179</c:f>
              <c:numCache>
                <c:formatCode>General</c:formatCode>
                <c:ptCount val="3"/>
                <c:pt idx="0">
                  <c:v>1.2862949924179352</c:v>
                </c:pt>
                <c:pt idx="1">
                  <c:v>1.4245748208719113</c:v>
                </c:pt>
                <c:pt idx="2">
                  <c:v>1.3196606781783828</c:v>
                </c:pt>
              </c:numCache>
            </c:numRef>
          </c:val>
        </c:ser>
        <c:ser>
          <c:idx val="2"/>
          <c:order val="2"/>
          <c:tx>
            <c:strRef>
              <c:f>'DPN &amp; DP0.1G.....1 '!$L$180</c:f>
              <c:strCache>
                <c:ptCount val="1"/>
                <c:pt idx="0">
                  <c:v>Gel-c TR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77:$O$177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80:$O$180</c:f>
              <c:numCache>
                <c:formatCode>General</c:formatCode>
                <c:ptCount val="3"/>
                <c:pt idx="0">
                  <c:v>5.36</c:v>
                </c:pt>
                <c:pt idx="1">
                  <c:v>3.49</c:v>
                </c:pt>
                <c:pt idx="2">
                  <c:v>2.6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-45"/>
        <c:axId val="-1706926320"/>
        <c:axId val="-1706924144"/>
      </c:barChart>
      <c:catAx>
        <c:axId val="-17069263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06924144"/>
        <c:crosses val="autoZero"/>
        <c:auto val="1"/>
        <c:lblAlgn val="ctr"/>
        <c:lblOffset val="100"/>
        <c:noMultiLvlLbl val="0"/>
      </c:catAx>
      <c:valAx>
        <c:axId val="-170692414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3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sz="13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RNA expression</a:t>
                </a:r>
                <a:endParaRPr lang="en-US" sz="13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1111111111111112E-2"/>
              <c:y val="0.1022685185185185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0692632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SMTN</a:t>
            </a:r>
          </a:p>
        </c:rich>
      </c:tx>
      <c:layout>
        <c:manualLayout>
          <c:xMode val="edge"/>
          <c:yMode val="edge"/>
          <c:x val="0.52757633420822392"/>
          <c:y val="5.555555555555555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PN &amp; DP0.1G.....1 '!$L$185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84:$O$184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85:$O$185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DPN &amp; DP0.1G.....1 '!$L$186</c:f>
              <c:strCache>
                <c:ptCount val="1"/>
                <c:pt idx="0">
                  <c:v>Gel-c U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84:$O$184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86:$O$186</c:f>
              <c:numCache>
                <c:formatCode>General</c:formatCode>
                <c:ptCount val="3"/>
                <c:pt idx="0">
                  <c:v>1.2700517493386101</c:v>
                </c:pt>
                <c:pt idx="1">
                  <c:v>1.1407921979900932</c:v>
                </c:pt>
                <c:pt idx="2">
                  <c:v>1.4580655909044336</c:v>
                </c:pt>
              </c:numCache>
            </c:numRef>
          </c:val>
        </c:ser>
        <c:ser>
          <c:idx val="2"/>
          <c:order val="2"/>
          <c:tx>
            <c:strRef>
              <c:f>'DPN &amp; DP0.1G.....1 '!$L$187</c:f>
              <c:strCache>
                <c:ptCount val="1"/>
                <c:pt idx="0">
                  <c:v>Gel-c TR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84:$O$184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87:$O$187</c:f>
              <c:numCache>
                <c:formatCode>General</c:formatCode>
                <c:ptCount val="3"/>
                <c:pt idx="0">
                  <c:v>2.89</c:v>
                </c:pt>
                <c:pt idx="1">
                  <c:v>2.5</c:v>
                </c:pt>
                <c:pt idx="2">
                  <c:v>2.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-45"/>
        <c:axId val="-1706931216"/>
        <c:axId val="-1706939376"/>
      </c:barChart>
      <c:catAx>
        <c:axId val="-1706931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06939376"/>
        <c:crosses val="autoZero"/>
        <c:auto val="1"/>
        <c:lblAlgn val="ctr"/>
        <c:lblOffset val="100"/>
        <c:noMultiLvlLbl val="0"/>
      </c:catAx>
      <c:valAx>
        <c:axId val="-17069393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3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sz="13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RNA expression</a:t>
                </a:r>
                <a:endParaRPr lang="en-US" sz="13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5000000000000001E-2"/>
              <c:y val="0.1162037037037037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069312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SM22-</a:t>
            </a:r>
            <a:r>
              <a:rPr lang="el-GR" sz="16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endParaRPr lang="en-US" sz="1600" b="1" i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c:rich>
      </c:tx>
      <c:layout>
        <c:manualLayout>
          <c:xMode val="edge"/>
          <c:yMode val="edge"/>
          <c:x val="0.5331596675415573"/>
          <c:y val="7.40740740740740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PN &amp; DP0.1G.....1 '!$L$17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71:$O$171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72:$O$172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DPN &amp; DP0.1G.....1 '!$L$173</c:f>
              <c:strCache>
                <c:ptCount val="1"/>
                <c:pt idx="0">
                  <c:v>Gel-c U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71:$O$171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73:$O$173</c:f>
              <c:numCache>
                <c:formatCode>General</c:formatCode>
                <c:ptCount val="3"/>
                <c:pt idx="0">
                  <c:v>1.4694319462855805</c:v>
                </c:pt>
                <c:pt idx="1">
                  <c:v>1.2419377915072767</c:v>
                </c:pt>
                <c:pt idx="2">
                  <c:v>1.2380692333129961</c:v>
                </c:pt>
              </c:numCache>
            </c:numRef>
          </c:val>
        </c:ser>
        <c:ser>
          <c:idx val="2"/>
          <c:order val="2"/>
          <c:tx>
            <c:strRef>
              <c:f>'DPN &amp; DP0.1G.....1 '!$L$174</c:f>
              <c:strCache>
                <c:ptCount val="1"/>
                <c:pt idx="0">
                  <c:v>Gel-c TR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71:$O$171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74:$O$174</c:f>
              <c:numCache>
                <c:formatCode>General</c:formatCode>
                <c:ptCount val="3"/>
                <c:pt idx="0">
                  <c:v>3.25</c:v>
                </c:pt>
                <c:pt idx="1">
                  <c:v>2.0499999999999998</c:v>
                </c:pt>
                <c:pt idx="2">
                  <c:v>2.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-45"/>
        <c:axId val="-1778628624"/>
        <c:axId val="-1778628080"/>
      </c:barChart>
      <c:catAx>
        <c:axId val="-177862862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78628080"/>
        <c:crosses val="autoZero"/>
        <c:auto val="1"/>
        <c:lblAlgn val="ctr"/>
        <c:lblOffset val="100"/>
        <c:noMultiLvlLbl val="0"/>
      </c:catAx>
      <c:valAx>
        <c:axId val="-1778628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3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sz="13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RNA expression</a:t>
                </a:r>
                <a:endParaRPr lang="en-US" sz="13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2.2222222222222223E-2"/>
              <c:y val="0.1254166666666666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7862862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l-GR" sz="16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α</a:t>
            </a:r>
            <a:r>
              <a:rPr lang="en-US" sz="16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-SMA</a:t>
            </a:r>
          </a:p>
        </c:rich>
      </c:tx>
      <c:layout>
        <c:manualLayout>
          <c:xMode val="edge"/>
          <c:yMode val="edge"/>
          <c:x val="0.44374300087489066"/>
          <c:y val="3.7037037037037035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PN &amp; DP0.1G.....1 '!$L$166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65:$O$165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66:$O$166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DPN &amp; DP0.1G.....1 '!$L$167</c:f>
              <c:strCache>
                <c:ptCount val="1"/>
                <c:pt idx="0">
                  <c:v>Gel-c UT</c:v>
                </c:pt>
              </c:strCache>
            </c:strRef>
          </c:tx>
          <c:spPr>
            <a:solidFill>
              <a:srgbClr val="FF000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65:$O$165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67:$O$167</c:f>
              <c:numCache>
                <c:formatCode>General</c:formatCode>
                <c:ptCount val="3"/>
                <c:pt idx="0">
                  <c:v>1.2677778621561526</c:v>
                </c:pt>
                <c:pt idx="1">
                  <c:v>1.3294625030829463</c:v>
                </c:pt>
                <c:pt idx="2">
                  <c:v>1.3723557179104633</c:v>
                </c:pt>
              </c:numCache>
            </c:numRef>
          </c:val>
        </c:ser>
        <c:ser>
          <c:idx val="2"/>
          <c:order val="2"/>
          <c:tx>
            <c:strRef>
              <c:f>'DPN &amp; DP0.1G.....1 '!$L$168</c:f>
              <c:strCache>
                <c:ptCount val="1"/>
                <c:pt idx="0">
                  <c:v>Gel-c TR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65:$O$165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68:$O$168</c:f>
              <c:numCache>
                <c:formatCode>General</c:formatCode>
                <c:ptCount val="3"/>
                <c:pt idx="0">
                  <c:v>2.19</c:v>
                </c:pt>
                <c:pt idx="1">
                  <c:v>2.2000000000000002</c:v>
                </c:pt>
                <c:pt idx="2">
                  <c:v>1.7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-45"/>
        <c:axId val="-1778630256"/>
        <c:axId val="-1778629168"/>
      </c:barChart>
      <c:catAx>
        <c:axId val="-1778630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78629168"/>
        <c:crosses val="autoZero"/>
        <c:auto val="1"/>
        <c:lblAlgn val="ctr"/>
        <c:lblOffset val="100"/>
        <c:noMultiLvlLbl val="0"/>
      </c:catAx>
      <c:valAx>
        <c:axId val="-1778629168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30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sz="1300" baseline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RNA expression</a:t>
                </a:r>
                <a:endParaRPr lang="en-US" sz="13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3888888888888888E-2"/>
              <c:y val="0.1161574074074074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7863025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600" b="1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600" b="1" i="1">
                <a:latin typeface="Times New Roman" panose="02020603050405020304" pitchFamily="18" charset="0"/>
                <a:cs typeface="Times New Roman" panose="02020603050405020304" pitchFamily="18" charset="0"/>
              </a:rPr>
              <a:t>MHY-11</a:t>
            </a:r>
          </a:p>
        </c:rich>
      </c:tx>
      <c:layout>
        <c:manualLayout>
          <c:xMode val="edge"/>
          <c:yMode val="edge"/>
          <c:x val="0.51945822397200347"/>
          <c:y val="6.9444444444444448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1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DPN &amp; DP0.1G.....1 '!$L$192</c:f>
              <c:strCache>
                <c:ptCount val="1"/>
                <c:pt idx="0">
                  <c:v>Control</c:v>
                </c:pt>
              </c:strCache>
            </c:strRef>
          </c:tx>
          <c:spPr>
            <a:solidFill>
              <a:srgbClr val="0070C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91:$O$191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92:$O$192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strRef>
              <c:f>'DPN &amp; DP0.1G.....1 '!$L$193</c:f>
              <c:strCache>
                <c:ptCount val="1"/>
                <c:pt idx="0">
                  <c:v>Gel-c UT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91:$O$191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93:$O$193</c:f>
              <c:numCache>
                <c:formatCode>General</c:formatCode>
                <c:ptCount val="3"/>
                <c:pt idx="0">
                  <c:v>1.1863314634857938</c:v>
                </c:pt>
                <c:pt idx="1">
                  <c:v>1.3272778589552301</c:v>
                </c:pt>
                <c:pt idx="2">
                  <c:v>1.3413149585793331</c:v>
                </c:pt>
              </c:numCache>
            </c:numRef>
          </c:val>
        </c:ser>
        <c:ser>
          <c:idx val="2"/>
          <c:order val="2"/>
          <c:tx>
            <c:strRef>
              <c:f>'DPN &amp; DP0.1G.....1 '!$L$194</c:f>
              <c:strCache>
                <c:ptCount val="1"/>
                <c:pt idx="0">
                  <c:v>Gel-c TRT</c:v>
                </c:pt>
              </c:strCache>
            </c:strRef>
          </c:tx>
          <c:spPr>
            <a:solidFill>
              <a:schemeClr val="accent3"/>
            </a:solidFill>
            <a:ln>
              <a:noFill/>
            </a:ln>
            <a:effectLst/>
          </c:spPr>
          <c:invertIfNegative val="0"/>
          <c:errBars>
            <c:errBarType val="both"/>
            <c:errValType val="percentage"/>
            <c:noEndCap val="0"/>
            <c:val val="5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DPN &amp; DP0.1G.....1 '!$M$191:$O$191</c:f>
              <c:strCache>
                <c:ptCount val="3"/>
                <c:pt idx="0">
                  <c:v>D7</c:v>
                </c:pt>
                <c:pt idx="1">
                  <c:v>D14</c:v>
                </c:pt>
                <c:pt idx="2">
                  <c:v>D21</c:v>
                </c:pt>
              </c:strCache>
            </c:strRef>
          </c:cat>
          <c:val>
            <c:numRef>
              <c:f>'DPN &amp; DP0.1G.....1 '!$M$194:$O$194</c:f>
              <c:numCache>
                <c:formatCode>General</c:formatCode>
                <c:ptCount val="3"/>
                <c:pt idx="0">
                  <c:v>5.75</c:v>
                </c:pt>
                <c:pt idx="1">
                  <c:v>3.89</c:v>
                </c:pt>
                <c:pt idx="2">
                  <c:v>2.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2"/>
        <c:overlap val="-45"/>
        <c:axId val="-1778632976"/>
        <c:axId val="-1778634064"/>
      </c:barChart>
      <c:catAx>
        <c:axId val="-17786329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222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78634064"/>
        <c:crosses val="autoZero"/>
        <c:auto val="1"/>
        <c:lblAlgn val="ctr"/>
        <c:lblOffset val="100"/>
        <c:noMultiLvlLbl val="0"/>
      </c:catAx>
      <c:valAx>
        <c:axId val="-1778634064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3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en-US" sz="13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lative</a:t>
                </a:r>
                <a:r>
                  <a:rPr lang="en-US" sz="1300" baseline="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RNA expression</a:t>
                </a:r>
                <a:endParaRPr lang="en-US" sz="13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>
            <c:manualLayout>
              <c:xMode val="edge"/>
              <c:yMode val="edge"/>
              <c:x val="1.3888888888888888E-2"/>
              <c:y val="0.130046296296296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3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General" sourceLinked="1"/>
        <c:majorTickMark val="out"/>
        <c:minorTickMark val="none"/>
        <c:tickLblPos val="nextTo"/>
        <c:spPr>
          <a:noFill/>
          <a:ln w="2222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-177863297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solidFill>
        <a:sysClr val="windowText" lastClr="000000"/>
      </a:solidFill>
      <a:round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545840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12805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89941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963654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69922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759410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713310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065474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33406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03577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34553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06C41C-5878-4E51-BCA3-140BA7D53CA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12/29/2020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D0BF8A-35D7-4CF3-A541-0D2DD3BB45A4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185612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0" name="Group 39"/>
          <p:cNvGrpSpPr/>
          <p:nvPr/>
        </p:nvGrpSpPr>
        <p:grpSpPr>
          <a:xfrm>
            <a:off x="1911340" y="62661"/>
            <a:ext cx="9443171" cy="8662240"/>
            <a:chOff x="1911340" y="62661"/>
            <a:chExt cx="9443171" cy="8662240"/>
          </a:xfrm>
        </p:grpSpPr>
        <p:grpSp>
          <p:nvGrpSpPr>
            <p:cNvPr id="26" name="Group 25"/>
            <p:cNvGrpSpPr/>
            <p:nvPr/>
          </p:nvGrpSpPr>
          <p:grpSpPr>
            <a:xfrm>
              <a:off x="1911340" y="3022181"/>
              <a:ext cx="4572000" cy="2743200"/>
              <a:chOff x="1203277" y="3585949"/>
              <a:chExt cx="4572000" cy="2743200"/>
            </a:xfrm>
          </p:grpSpPr>
          <p:graphicFrame>
            <p:nvGraphicFramePr>
              <p:cNvPr id="5" name="Chart 4"/>
              <p:cNvGraphicFramePr>
                <a:graphicFrameLocks/>
              </p:cNvGraphicFramePr>
              <p:nvPr/>
            </p:nvGraphicFramePr>
            <p:xfrm>
              <a:off x="1203277" y="3585949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9" name="TextBox 8"/>
              <p:cNvSpPr txBox="1"/>
              <p:nvPr/>
            </p:nvSpPr>
            <p:spPr>
              <a:xfrm>
                <a:off x="2684233" y="3923851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972249" y="4452585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5255391" y="4677422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5" name="Group 24"/>
            <p:cNvGrpSpPr/>
            <p:nvPr/>
          </p:nvGrpSpPr>
          <p:grpSpPr>
            <a:xfrm>
              <a:off x="6782511" y="3022181"/>
              <a:ext cx="4572000" cy="2743200"/>
              <a:chOff x="6553200" y="3585949"/>
              <a:chExt cx="4572000" cy="2743200"/>
            </a:xfrm>
          </p:grpSpPr>
          <p:graphicFrame>
            <p:nvGraphicFramePr>
              <p:cNvPr id="6" name="Chart 5"/>
              <p:cNvGraphicFramePr>
                <a:graphicFrameLocks/>
              </p:cNvGraphicFramePr>
              <p:nvPr/>
            </p:nvGraphicFramePr>
            <p:xfrm>
              <a:off x="6553200" y="3585949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9353045" y="4231817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8103765" y="4050461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0602104" y="4421205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24" name="Group 23"/>
            <p:cNvGrpSpPr/>
            <p:nvPr/>
          </p:nvGrpSpPr>
          <p:grpSpPr>
            <a:xfrm>
              <a:off x="6782511" y="62661"/>
              <a:ext cx="4572000" cy="2743200"/>
              <a:chOff x="7047032" y="555761"/>
              <a:chExt cx="4572000" cy="2743200"/>
            </a:xfrm>
          </p:grpSpPr>
          <p:graphicFrame>
            <p:nvGraphicFramePr>
              <p:cNvPr id="4" name="Chart 3"/>
              <p:cNvGraphicFramePr>
                <a:graphicFrameLocks/>
              </p:cNvGraphicFramePr>
              <p:nvPr/>
            </p:nvGraphicFramePr>
            <p:xfrm>
              <a:off x="7047032" y="555761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7" name="TextBox 6"/>
              <p:cNvSpPr txBox="1"/>
              <p:nvPr/>
            </p:nvSpPr>
            <p:spPr>
              <a:xfrm>
                <a:off x="8597597" y="1034178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1098840" y="1327742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9846877" y="1544340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1911340" y="62661"/>
              <a:ext cx="4572000" cy="2743200"/>
              <a:chOff x="-2673403" y="-478608"/>
              <a:chExt cx="4572000" cy="2743200"/>
            </a:xfrm>
          </p:grpSpPr>
          <p:grpSp>
            <p:nvGrpSpPr>
              <p:cNvPr id="27" name="Group 26"/>
              <p:cNvGrpSpPr/>
              <p:nvPr/>
            </p:nvGrpSpPr>
            <p:grpSpPr>
              <a:xfrm>
                <a:off x="-2673403" y="-478608"/>
                <a:ext cx="4572000" cy="2743200"/>
                <a:chOff x="1194684" y="593133"/>
                <a:chExt cx="4572000" cy="2743200"/>
              </a:xfrm>
            </p:grpSpPr>
            <p:graphicFrame>
              <p:nvGraphicFramePr>
                <p:cNvPr id="18" name="Chart 17"/>
                <p:cNvGraphicFramePr>
                  <a:graphicFrameLocks/>
                </p:cNvGraphicFramePr>
                <p:nvPr/>
              </p:nvGraphicFramePr>
              <p:xfrm>
                <a:off x="1194684" y="593133"/>
                <a:ext cx="4572000" cy="274320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19" name="TextBox 18"/>
                <p:cNvSpPr txBox="1"/>
                <p:nvPr/>
              </p:nvSpPr>
              <p:spPr>
                <a:xfrm>
                  <a:off x="3998489" y="958696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prstClr val="black"/>
                      </a:solidFill>
                    </a:rPr>
                    <a:t>*</a:t>
                  </a:r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5250452" y="1283314"/>
                  <a:ext cx="300082" cy="369332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dirty="0">
                      <a:solidFill>
                        <a:prstClr val="black"/>
                      </a:solidFill>
                    </a:rPr>
                    <a:t>*</a:t>
                  </a:r>
                  <a:endParaRPr lang="en-US" dirty="0">
                    <a:solidFill>
                      <a:prstClr val="black"/>
                    </a:solidFill>
                  </a:endParaRPr>
                </a:p>
              </p:txBody>
            </p:sp>
          </p:grpSp>
          <p:sp>
            <p:nvSpPr>
              <p:cNvPr id="33" name="TextBox 32"/>
              <p:cNvSpPr txBox="1"/>
              <p:nvPr/>
            </p:nvSpPr>
            <p:spPr>
              <a:xfrm>
                <a:off x="-1123283" y="-119992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4197340" y="5981701"/>
              <a:ext cx="4572000" cy="2743200"/>
              <a:chOff x="3799004" y="2102824"/>
              <a:chExt cx="4572000" cy="2743200"/>
            </a:xfrm>
          </p:grpSpPr>
          <p:graphicFrame>
            <p:nvGraphicFramePr>
              <p:cNvPr id="36" name="Chart 35"/>
              <p:cNvGraphicFramePr>
                <a:graphicFrameLocks/>
              </p:cNvGraphicFramePr>
              <p:nvPr/>
            </p:nvGraphicFramePr>
            <p:xfrm>
              <a:off x="3799004" y="2102824"/>
              <a:ext cx="4572000" cy="27432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37" name="TextBox 36"/>
              <p:cNvSpPr txBox="1"/>
              <p:nvPr/>
            </p:nvSpPr>
            <p:spPr>
              <a:xfrm>
                <a:off x="5276286" y="2565249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>
                <a:off x="6558852" y="3006561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7845491" y="3289920"/>
                <a:ext cx="300082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>
                    <a:solidFill>
                      <a:prstClr val="black"/>
                    </a:solidFill>
                  </a:rPr>
                  <a:t>*</a:t>
                </a:r>
                <a:endParaRPr lang="en-US" dirty="0">
                  <a:solidFill>
                    <a:prstClr val="black"/>
                  </a:solidFill>
                </a:endParaRPr>
              </a:p>
            </p:txBody>
          </p:sp>
        </p:grpSp>
      </p:grpSp>
      <p:sp>
        <p:nvSpPr>
          <p:cNvPr id="29" name="TextBox 28"/>
          <p:cNvSpPr txBox="1"/>
          <p:nvPr/>
        </p:nvSpPr>
        <p:spPr>
          <a:xfrm>
            <a:off x="-810458" y="421277"/>
            <a:ext cx="26362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</a:t>
            </a:r>
            <a:endParaRPr lang="en-US" b="1" dirty="0">
              <a:solidFill>
                <a:prstClr val="black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3359491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1</Words>
  <Application>Microsoft Office PowerPoint</Application>
  <PresentationFormat>Widescreen</PresentationFormat>
  <Paragraphs>2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1_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</cp:revision>
  <dcterms:created xsi:type="dcterms:W3CDTF">2020-12-29T00:57:01Z</dcterms:created>
  <dcterms:modified xsi:type="dcterms:W3CDTF">2020-12-29T00:57:35Z</dcterms:modified>
</cp:coreProperties>
</file>